
<file path=[Content_Types].xml><?xml version="1.0" encoding="utf-8"?>
<Types xmlns="http://schemas.openxmlformats.org/package/2006/content-types"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4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ABAB"/>
    <a:srgbClr val="767171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3"/>
  </p:normalViewPr>
  <p:slideViewPr>
    <p:cSldViewPr snapToGrid="0" snapToObjects="1">
      <p:cViewPr>
        <p:scale>
          <a:sx n="57" d="100"/>
          <a:sy n="57" d="100"/>
        </p:scale>
        <p:origin x="9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E35D04-F06A-1746-8CEE-8B514FCBA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0007155-1C1F-FD4D-B4D2-88DCB143EB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487C01C-229C-414E-BB77-F4BB8844B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1D5AC3-26DA-3745-88D3-5C87D9F99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22FC800-B5D9-2743-B590-E4713FACD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3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81392E-03BE-D54E-B749-3C4E7461C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D576FF8-30F6-C440-9853-E605DED799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8F5B0D6-D43F-704F-94A6-8A70AC579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34B5BC8-9E07-8744-83F2-236B0A802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522CA05-2388-1740-A7AE-468E1623E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3409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F7AE445-D9F6-7243-9095-6BDA90AD3D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B23E3DE-CBE3-6E4F-BF8E-2BFE8588FF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7BA967F-712B-694C-9EA9-E7CDCBA26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B2B580F-46F6-714A-BDA1-0F58CF0E8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6D71A2C-9DF3-BD47-9C08-52758D8C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12652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220FA2-F925-D84A-9AC6-2BC0BD4EF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F573D4-D4C8-8742-9355-7033A8940C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9166C5C-C802-A44B-859B-CDA4F087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4D8038-C761-A745-9F17-33083EF45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7C70B0-67AB-594C-8A14-78E379381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6880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845248-61F4-F84D-B175-E9CC92FAA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8F3156A-8506-B148-96AC-D5AD371F0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9B4EAD2-41F3-FE4F-BBA5-AA04DA806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1A0AEC0-0F69-C440-87E6-443B57CFD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792747A-5AF2-944D-9769-73005DE98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35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F5E525-CB95-2648-B125-26332B956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D689BEE-011D-3540-9EC0-A98897287C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637126C-C0C6-CE44-839E-3A0D6FA0A1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589F00B8-EC86-774E-947D-7E9E6540C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5B072FB-FD12-1F42-9CE0-BC6756019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5D7C1E8-437C-534C-9897-4092352C2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6744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4C5A4F-F029-544B-929D-E004DDC89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30664DA-0241-534D-A280-5F294ECF3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9A655CB-0C03-0348-8BE0-8DFDC4790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EF61E243-C31A-1E43-8220-E794EF8CD1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7613710-7A82-A844-A106-3BA599CF30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CF70AB4D-958D-E145-9CEB-D79C5943D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918BCF4-8EE6-B542-81D8-6EB8FA950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C4123B0C-76A1-BE4F-A9D7-56A1A4567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80763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277EB9-F9C1-F349-829F-987A849E7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CC56CB96-61A7-DE41-9469-6A893C3A1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B6EEF1A5-5B70-114E-9D6D-6A68E0030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2FE25BEE-A896-5D49-A1DA-37E12B424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48366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7F90CEC0-345B-6246-978E-1A56D765D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2F61B865-24C9-074B-816A-A568995C1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1A4FDBA-79EE-8749-AA73-25DF8CFA0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974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EB9312-CCF8-454E-B09D-3C7E970F6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91D2C49-CDBF-2C47-9B75-B6487A2101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1EC0A8D-0BEF-5143-8351-302124FD4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61FFFD4-50C0-8149-89BB-C8F16CA60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799687F-24F1-3646-B97B-D7951F2E4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EBFAD89-B06B-E34A-8070-A4CFBA4E6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3311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360A32-557E-7A44-813A-354941B06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4289B997-F045-A84D-B010-49CF848118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8127117-70E7-634B-860E-3DE3B5D754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276A3B5-863E-CE46-9C53-E32F3F0D2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99F04A1-4A15-A645-916A-41E9C3D57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CA0356B-3932-A247-9CBA-A4C8BFBF2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5633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492E6718-E617-D34F-B325-9E2749742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7CCD09B-D538-4B4B-B775-602D7C5113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7A96B73-39C7-CE4D-8EFC-1609C264EB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A3864C4-E135-C04F-969E-1D08B0A1C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59420BB-5753-0544-B77C-91F0CB8C30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54046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jp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5989670" y="1411761"/>
            <a:ext cx="5861957" cy="5138928"/>
            <a:chOff x="6096000" y="1007712"/>
            <a:chExt cx="5861957" cy="5138928"/>
          </a:xfrm>
        </p:grpSpPr>
        <p:pic>
          <p:nvPicPr>
            <p:cNvPr id="5" name="Imagem 4">
              <a:extLst>
                <a:ext uri="{FF2B5EF4-FFF2-40B4-BE49-F238E27FC236}">
                  <a16:creationId xmlns:a16="http://schemas.microsoft.com/office/drawing/2014/main" id="{CDCED0E0-95CA-9340-8022-CEA8BC087E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2093" t="5006" r="11574" b="8646"/>
            <a:stretch/>
          </p:blipFill>
          <p:spPr>
            <a:xfrm>
              <a:off x="6096000" y="1007712"/>
              <a:ext cx="5861957" cy="5138928"/>
            </a:xfrm>
            <a:prstGeom prst="rect">
              <a:avLst/>
            </a:prstGeom>
          </p:spPr>
        </p:pic>
        <p:sp>
          <p:nvSpPr>
            <p:cNvPr id="6" name="CaixaDeTexto 5">
              <a:extLst>
                <a:ext uri="{FF2B5EF4-FFF2-40B4-BE49-F238E27FC236}">
                  <a16:creationId xmlns:a16="http://schemas.microsoft.com/office/drawing/2014/main" id="{619A10E6-29E4-204E-86BF-6326C6F2AC20}"/>
                </a:ext>
              </a:extLst>
            </p:cNvPr>
            <p:cNvSpPr txBox="1"/>
            <p:nvPr/>
          </p:nvSpPr>
          <p:spPr>
            <a:xfrm>
              <a:off x="6708782" y="4095207"/>
              <a:ext cx="1671073" cy="3816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i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Inspiration</a:t>
              </a:r>
            </a:p>
          </p:txBody>
        </p:sp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06735994-A041-6B4B-94AB-8F7BB894F59B}"/>
                </a:ext>
              </a:extLst>
            </p:cNvPr>
            <p:cNvSpPr txBox="1"/>
            <p:nvPr/>
          </p:nvSpPr>
          <p:spPr>
            <a:xfrm>
              <a:off x="9328392" y="3896816"/>
              <a:ext cx="13454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i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Expiration</a:t>
              </a:r>
            </a:p>
          </p:txBody>
        </p:sp>
        <p:sp>
          <p:nvSpPr>
            <p:cNvPr id="9" name="CaixaDeTexto 8">
              <a:extLst>
                <a:ext uri="{FF2B5EF4-FFF2-40B4-BE49-F238E27FC236}">
                  <a16:creationId xmlns:a16="http://schemas.microsoft.com/office/drawing/2014/main" id="{710B6AA5-BADD-7143-BE06-2B65F360409C}"/>
                </a:ext>
              </a:extLst>
            </p:cNvPr>
            <p:cNvSpPr txBox="1"/>
            <p:nvPr/>
          </p:nvSpPr>
          <p:spPr>
            <a:xfrm>
              <a:off x="10278494" y="4955116"/>
              <a:ext cx="16710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2400" b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IVCCI = 41%</a:t>
              </a:r>
            </a:p>
          </p:txBody>
        </p:sp>
      </p:grpSp>
      <p:pic>
        <p:nvPicPr>
          <p:cNvPr id="10" name="Mídia Online 9" descr="12.45.10 horas __[0000356].mp4">
            <a:hlinkClick r:id="" action="ppaction://media"/>
            <a:extLst>
              <a:ext uri="{FF2B5EF4-FFF2-40B4-BE49-F238E27FC236}">
                <a16:creationId xmlns:a16="http://schemas.microsoft.com/office/drawing/2014/main" id="{2AE51C0D-918E-0F4B-8F29-2F5964ADD03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7"/>
          <a:srcRect l="23555" t="31426" r="36594" b="31638"/>
          <a:stretch/>
        </p:blipFill>
        <p:spPr>
          <a:xfrm>
            <a:off x="7081297" y="1424782"/>
            <a:ext cx="3794168" cy="2715768"/>
          </a:xfrm>
          <a:prstGeom prst="rect">
            <a:avLst/>
          </a:prstGeom>
          <a:ln>
            <a:solidFill>
              <a:schemeClr val="accent5">
                <a:lumMod val="20000"/>
                <a:lumOff val="80000"/>
              </a:schemeClr>
            </a:solidFill>
          </a:ln>
        </p:spPr>
      </p:pic>
      <p:sp>
        <p:nvSpPr>
          <p:cNvPr id="11" name="CaixaDeTexto 10">
            <a:extLst>
              <a:ext uri="{FF2B5EF4-FFF2-40B4-BE49-F238E27FC236}">
                <a16:creationId xmlns:a16="http://schemas.microsoft.com/office/drawing/2014/main" id="{9BB9B4A9-92A4-5A4D-BE65-B6BB5C69FA57}"/>
              </a:ext>
            </a:extLst>
          </p:cNvPr>
          <p:cNvSpPr txBox="1"/>
          <p:nvPr/>
        </p:nvSpPr>
        <p:spPr>
          <a:xfrm>
            <a:off x="8473307" y="1958278"/>
            <a:ext cx="140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IVC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3C3B9783-B1B1-2649-B743-331723650F36}"/>
              </a:ext>
            </a:extLst>
          </p:cNvPr>
          <p:cNvSpPr txBox="1"/>
          <p:nvPr/>
        </p:nvSpPr>
        <p:spPr>
          <a:xfrm>
            <a:off x="9630168" y="1577589"/>
            <a:ext cx="943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Liver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248476" y="288775"/>
            <a:ext cx="2246600" cy="52322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Profile 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ideo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 rot="1860000" flipH="1">
            <a:off x="8891099" y="1757704"/>
            <a:ext cx="59635" cy="548640"/>
          </a:xfrm>
          <a:prstGeom prst="line">
            <a:avLst/>
          </a:prstGeom>
          <a:ln w="2857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Mídia Online 3" descr="12.32.30 horas __[0000305].mp4">
            <a:hlinkClick r:id="" action="ppaction://media"/>
            <a:extLst>
              <a:ext uri="{FF2B5EF4-FFF2-40B4-BE49-F238E27FC236}">
                <a16:creationId xmlns:a16="http://schemas.microsoft.com/office/drawing/2014/main" id="{FB786C0A-9EA8-2040-A4D2-5BA59304A455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8"/>
          <a:srcRect l="27396" t="9841" r="28290" b="35252"/>
          <a:stretch/>
        </p:blipFill>
        <p:spPr>
          <a:xfrm>
            <a:off x="246645" y="1434378"/>
            <a:ext cx="5470205" cy="5083380"/>
          </a:xfrm>
          <a:prstGeom prst="rect">
            <a:avLst/>
          </a:prstGeom>
        </p:spPr>
      </p:pic>
      <p:sp>
        <p:nvSpPr>
          <p:cNvPr id="22" name="CaixaDeTexto 13">
            <a:extLst>
              <a:ext uri="{FF2B5EF4-FFF2-40B4-BE49-F238E27FC236}">
                <a16:creationId xmlns:a16="http://schemas.microsoft.com/office/drawing/2014/main" id="{F0348232-17FE-EB42-AE37-8E59F468F1F5}"/>
              </a:ext>
            </a:extLst>
          </p:cNvPr>
          <p:cNvSpPr txBox="1"/>
          <p:nvPr/>
        </p:nvSpPr>
        <p:spPr>
          <a:xfrm>
            <a:off x="-48010" y="2782666"/>
            <a:ext cx="1159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Rib</a:t>
            </a:r>
          </a:p>
        </p:txBody>
      </p:sp>
      <p:sp>
        <p:nvSpPr>
          <p:cNvPr id="23" name="CaixaDeTexto 14">
            <a:extLst>
              <a:ext uri="{FF2B5EF4-FFF2-40B4-BE49-F238E27FC236}">
                <a16:creationId xmlns:a16="http://schemas.microsoft.com/office/drawing/2014/main" id="{C19A4E24-51E9-1847-8E21-89A4DF86182D}"/>
              </a:ext>
            </a:extLst>
          </p:cNvPr>
          <p:cNvSpPr txBox="1"/>
          <p:nvPr/>
        </p:nvSpPr>
        <p:spPr>
          <a:xfrm>
            <a:off x="2425503" y="2270967"/>
            <a:ext cx="17764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Pleural line</a:t>
            </a:r>
          </a:p>
        </p:txBody>
      </p:sp>
      <p:sp>
        <p:nvSpPr>
          <p:cNvPr id="24" name="CaixaDeTexto 18">
            <a:extLst>
              <a:ext uri="{FF2B5EF4-FFF2-40B4-BE49-F238E27FC236}">
                <a16:creationId xmlns:a16="http://schemas.microsoft.com/office/drawing/2014/main" id="{A8A52464-B85E-784B-BD9B-B2CFBEB5EB49}"/>
              </a:ext>
            </a:extLst>
          </p:cNvPr>
          <p:cNvSpPr txBox="1"/>
          <p:nvPr/>
        </p:nvSpPr>
        <p:spPr>
          <a:xfrm>
            <a:off x="262697" y="5910759"/>
            <a:ext cx="1159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A-lines</a:t>
            </a:r>
          </a:p>
        </p:txBody>
      </p:sp>
      <p:cxnSp>
        <p:nvCxnSpPr>
          <p:cNvPr id="25" name="Conector de Seta Reta 19">
            <a:extLst>
              <a:ext uri="{FF2B5EF4-FFF2-40B4-BE49-F238E27FC236}">
                <a16:creationId xmlns:a16="http://schemas.microsoft.com/office/drawing/2014/main" id="{DC64872A-323B-4B40-AECF-931D5F12918B}"/>
              </a:ext>
            </a:extLst>
          </p:cNvPr>
          <p:cNvCxnSpPr>
            <a:cxnSpLocks/>
          </p:cNvCxnSpPr>
          <p:nvPr/>
        </p:nvCxnSpPr>
        <p:spPr>
          <a:xfrm flipV="1">
            <a:off x="1628295" y="4571057"/>
            <a:ext cx="1412617" cy="159158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>
            <a:off x="1628295" y="6162642"/>
            <a:ext cx="2403955" cy="8064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ixaDeTexto 11">
            <a:extLst>
              <a:ext uri="{FF2B5EF4-FFF2-40B4-BE49-F238E27FC236}">
                <a16:creationId xmlns:a16="http://schemas.microsoft.com/office/drawing/2014/main" id="{A38519EB-8EBE-E54E-A63E-D3DA137FDB3E}"/>
              </a:ext>
            </a:extLst>
          </p:cNvPr>
          <p:cNvSpPr txBox="1"/>
          <p:nvPr/>
        </p:nvSpPr>
        <p:spPr>
          <a:xfrm>
            <a:off x="7030053" y="3757553"/>
            <a:ext cx="1726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Subcostal view</a:t>
            </a:r>
          </a:p>
        </p:txBody>
      </p:sp>
      <p:sp>
        <p:nvSpPr>
          <p:cNvPr id="32" name="CaixaDeTexto 23">
            <a:extLst>
              <a:ext uri="{FF2B5EF4-FFF2-40B4-BE49-F238E27FC236}">
                <a16:creationId xmlns:a16="http://schemas.microsoft.com/office/drawing/2014/main" id="{9351AB2E-2DE7-774D-A8CD-C7C77A6501F2}"/>
              </a:ext>
            </a:extLst>
          </p:cNvPr>
          <p:cNvSpPr txBox="1"/>
          <p:nvPr/>
        </p:nvSpPr>
        <p:spPr>
          <a:xfrm>
            <a:off x="4113292" y="6106467"/>
            <a:ext cx="1645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Anterior view</a:t>
            </a:r>
          </a:p>
        </p:txBody>
      </p:sp>
      <p:grpSp>
        <p:nvGrpSpPr>
          <p:cNvPr id="14" name="Groupe 13"/>
          <p:cNvGrpSpPr/>
          <p:nvPr/>
        </p:nvGrpSpPr>
        <p:grpSpPr>
          <a:xfrm>
            <a:off x="246644" y="971382"/>
            <a:ext cx="5470206" cy="430887"/>
            <a:chOff x="246644" y="901809"/>
            <a:chExt cx="5470206" cy="430887"/>
          </a:xfrm>
        </p:grpSpPr>
        <p:sp>
          <p:nvSpPr>
            <p:cNvPr id="17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246644" y="901809"/>
              <a:ext cx="5470206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pt-BR" sz="2200" dirty="0"/>
                <a:t>Lung Ultrasound                    A-lines</a:t>
              </a:r>
            </a:p>
          </p:txBody>
        </p:sp>
        <p:cxnSp>
          <p:nvCxnSpPr>
            <p:cNvPr id="4" name="Connecteur droit avec flèche 3"/>
            <p:cNvCxnSpPr/>
            <p:nvPr/>
          </p:nvCxnSpPr>
          <p:spPr>
            <a:xfrm flipV="1">
              <a:off x="3050851" y="1143000"/>
              <a:ext cx="99133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e 6"/>
          <p:cNvGrpSpPr/>
          <p:nvPr/>
        </p:nvGrpSpPr>
        <p:grpSpPr>
          <a:xfrm>
            <a:off x="5989670" y="956046"/>
            <a:ext cx="5861957" cy="430887"/>
            <a:chOff x="5989670" y="866595"/>
            <a:chExt cx="5861957" cy="430887"/>
          </a:xfrm>
        </p:grpSpPr>
        <p:sp>
          <p:nvSpPr>
            <p:cNvPr id="13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5989670" y="866595"/>
              <a:ext cx="5861957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r>
                <a:rPr lang="pt-BR" sz="2200" dirty="0"/>
                <a:t>Inferior veina cava collapsibillity                  positive</a:t>
              </a:r>
            </a:p>
          </p:txBody>
        </p:sp>
        <p:cxnSp>
          <p:nvCxnSpPr>
            <p:cNvPr id="26" name="Connecteur droit avec flèche 25"/>
            <p:cNvCxnSpPr/>
            <p:nvPr/>
          </p:nvCxnSpPr>
          <p:spPr>
            <a:xfrm flipV="1">
              <a:off x="9804282" y="1123122"/>
              <a:ext cx="9144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CaixaDeTexto 3">
            <a:extLst>
              <a:ext uri="{FF2B5EF4-FFF2-40B4-BE49-F238E27FC236}">
                <a16:creationId xmlns:a16="http://schemas.microsoft.com/office/drawing/2014/main" id="{CFDE78E7-DA3F-DB4A-A13B-375661A86079}"/>
              </a:ext>
            </a:extLst>
          </p:cNvPr>
          <p:cNvSpPr txBox="1"/>
          <p:nvPr/>
        </p:nvSpPr>
        <p:spPr>
          <a:xfrm>
            <a:off x="9777911" y="3229892"/>
            <a:ext cx="8060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dirty="0">
                <a:solidFill>
                  <a:schemeClr val="bg1"/>
                </a:solidFill>
              </a:rPr>
              <a:t>Right atrium</a:t>
            </a:r>
          </a:p>
        </p:txBody>
      </p:sp>
    </p:spTree>
    <p:extLst>
      <p:ext uri="{BB962C8B-B14F-4D97-AF65-F5344CB8AC3E}">
        <p14:creationId xmlns:p14="http://schemas.microsoft.com/office/powerpoint/2010/main" val="8001953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65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4000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22" repeatCount="indefinite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</TotalTime>
  <Words>29</Words>
  <Application>Microsoft Macintosh PowerPoint</Application>
  <PresentationFormat>Widescreen</PresentationFormat>
  <Paragraphs>14</Paragraphs>
  <Slides>1</Slides>
  <Notes>0</Notes>
  <HiddenSlides>0</HiddenSlides>
  <MMClips>2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hel Pordeus</dc:creator>
  <cp:lastModifiedBy>Rogerio Passos</cp:lastModifiedBy>
  <cp:revision>41</cp:revision>
  <dcterms:created xsi:type="dcterms:W3CDTF">2019-06-26T13:56:10Z</dcterms:created>
  <dcterms:modified xsi:type="dcterms:W3CDTF">2019-06-29T21:41:36Z</dcterms:modified>
</cp:coreProperties>
</file>